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536" autoAdjust="0"/>
    <p:restoredTop sz="94660"/>
  </p:normalViewPr>
  <p:slideViewPr>
    <p:cSldViewPr snapToGrid="0" showGuides="1">
      <p:cViewPr varScale="1">
        <p:scale>
          <a:sx n="46" d="100"/>
          <a:sy n="46" d="100"/>
        </p:scale>
        <p:origin x="1809" y="8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e-IL"/>
              <a:t>לחץ כדי לערוך סגנון כותרת משנה של תבנית בסיס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42385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7926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80745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64988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5137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22587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50445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80118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964224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7105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e-IL"/>
              <a:t>לחץ על הסמל כדי להוסיף תמונה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04943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22102-17BF-44BC-8CE9-F5420CDD7C55}" type="datetimeFigureOut">
              <a:rPr lang="he-IL" smtClean="0"/>
              <a:t>ד'/תשרי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60533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מלבן 3"/>
          <p:cNvSpPr/>
          <p:nvPr/>
        </p:nvSpPr>
        <p:spPr>
          <a:xfrm>
            <a:off x="354529" y="540902"/>
            <a:ext cx="6183003" cy="8901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ure 3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ell potency of fresh CAR T cells from day 10 and the same sample 6 weeks 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fter cryopreservation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etermined by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ecretion after co-culture with CD19 expressing target cell lines (NALM-6, CD19-K562) and negative cell line (CCRL-CEM).</a:t>
            </a:r>
          </a:p>
        </p:txBody>
      </p:sp>
      <p:pic>
        <p:nvPicPr>
          <p:cNvPr id="2" name="תמונה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9000" y="1746398"/>
            <a:ext cx="3240000" cy="22176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1899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ערכת נושא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ערכת נושא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ערכת נושא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47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he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יצחקי אורית, דר</dc:creator>
  <cp:lastModifiedBy>michal Besser</cp:lastModifiedBy>
  <cp:revision>11</cp:revision>
  <dcterms:created xsi:type="dcterms:W3CDTF">2022-09-18T07:12:22Z</dcterms:created>
  <dcterms:modified xsi:type="dcterms:W3CDTF">2022-09-29T06:43:29Z</dcterms:modified>
</cp:coreProperties>
</file>